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11D41FB-1DED-4F4A-BEEA-A62F845BB244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71600" y="487440"/>
            <a:ext cx="5914800" cy="1766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71600" y="2433600"/>
            <a:ext cx="591480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71600" y="5464440"/>
            <a:ext cx="591480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A4F02B3-835F-4119-B952-C4DF750862D4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71600" y="487440"/>
            <a:ext cx="5914800" cy="1766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71600" y="2433600"/>
            <a:ext cx="288612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2440" y="2433600"/>
            <a:ext cx="288612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71600" y="5464440"/>
            <a:ext cx="288612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2440" y="5464440"/>
            <a:ext cx="288612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EBBF6A0-73A3-4D17-B49F-754852F09ED1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71600" y="487440"/>
            <a:ext cx="5914800" cy="1766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71600" y="2433600"/>
            <a:ext cx="190440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71760" y="2433600"/>
            <a:ext cx="190440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471560" y="2433600"/>
            <a:ext cx="190440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71600" y="5464440"/>
            <a:ext cx="190440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71760" y="5464440"/>
            <a:ext cx="190440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471560" y="5464440"/>
            <a:ext cx="190440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6F8025C-9F18-40D2-B1BE-42896E7BEC28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71600" y="487440"/>
            <a:ext cx="5914800" cy="1766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71600" y="2433600"/>
            <a:ext cx="5914800" cy="58024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0000"/>
              </a:lnSpc>
              <a:spcBef>
                <a:spcPts val="751"/>
              </a:spcBef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8EFE991-304E-4A3A-AB19-6C6B0D0D00AB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71600" y="487440"/>
            <a:ext cx="5914800" cy="1766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71600" y="2433600"/>
            <a:ext cx="5914800" cy="5802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41793EC-5B01-41AA-9605-44056CA756C0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71600" y="487440"/>
            <a:ext cx="5914800" cy="1766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71600" y="2433600"/>
            <a:ext cx="2886120" cy="5802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2440" y="2433600"/>
            <a:ext cx="2886120" cy="5802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72F02C7-C3F6-49ED-B4D6-8C78E32CD898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71600" y="487440"/>
            <a:ext cx="5914800" cy="1766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89E9405-701E-4636-8B9C-70319AC2EEF1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71600" y="487440"/>
            <a:ext cx="5914800" cy="81914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lnSpc>
                <a:spcPct val="90000"/>
              </a:lnSpc>
              <a:spcBef>
                <a:spcPts val="751"/>
              </a:spcBef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DCC8C55-A1ED-4C44-B094-120068862FE9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71600" y="487440"/>
            <a:ext cx="5914800" cy="1766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71600" y="2433600"/>
            <a:ext cx="288612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2440" y="2433600"/>
            <a:ext cx="2886120" cy="5802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71600" y="5464440"/>
            <a:ext cx="288612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B8EBF41-C23B-47C7-BAEF-A4EC986A1B1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71600" y="487440"/>
            <a:ext cx="5914800" cy="1766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71600" y="2433600"/>
            <a:ext cx="2886120" cy="5802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2440" y="2433600"/>
            <a:ext cx="288612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2440" y="5464440"/>
            <a:ext cx="288612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8AFBABB-D8D4-4EA3-95B7-DBE50A13F80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71600" y="487440"/>
            <a:ext cx="5914800" cy="1766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71600" y="2433600"/>
            <a:ext cx="288612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2440" y="2433600"/>
            <a:ext cx="288612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71600" y="5464440"/>
            <a:ext cx="591480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FE3FCAC-6529-4D55-930F-EE3527D5953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71600" y="487440"/>
            <a:ext cx="5914800" cy="1766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3300" spc="-1" strike="noStrike">
                <a:solidFill>
                  <a:srgbClr val="000000"/>
                </a:solidFill>
                <a:latin typeface="Calibri Light"/>
              </a:rPr>
              <a:t>Click to edit the title text format</a:t>
            </a:r>
            <a:endParaRPr b="0" lang="en-US" sz="33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71600" y="2433600"/>
            <a:ext cx="5914800" cy="5802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171360" indent="-171360">
              <a:lnSpc>
                <a:spcPct val="90000"/>
              </a:lnSpc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  <a:p>
            <a:pPr lvl="1" marL="514440" indent="-171360">
              <a:lnSpc>
                <a:spcPct val="90000"/>
              </a:lnSpc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  <a:p>
            <a:pPr lvl="2" marL="857160" indent="-171360">
              <a:lnSpc>
                <a:spcPct val="90000"/>
              </a:lnSpc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  <a:p>
            <a:pPr lvl="3" marL="1200240" indent="-171360">
              <a:lnSpc>
                <a:spcPct val="90000"/>
              </a:lnSpc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  <a:p>
            <a:pPr lvl="4" marL="1542960" indent="-171360">
              <a:lnSpc>
                <a:spcPct val="90000"/>
              </a:lnSpc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  <a:p>
            <a:pPr lvl="5" marL="1542960" indent="-171360">
              <a:lnSpc>
                <a:spcPct val="90000"/>
              </a:lnSpc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  <a:p>
            <a:pPr lvl="6" marL="1542960" indent="-171360">
              <a:lnSpc>
                <a:spcPct val="90000"/>
              </a:lnSpc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71600" y="8475480"/>
            <a:ext cx="154296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ko-KR" sz="9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ko-KR" sz="9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271600" y="8475480"/>
            <a:ext cx="23148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843440" y="8475480"/>
            <a:ext cx="154296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ko-KR" sz="9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C13FC539-9B0A-40A7-9D97-DBB7995399F9}" type="slidenum">
              <a:rPr b="0" lang="ko-KR" sz="9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image" Target="../media/image4.png"/><Relationship Id="rId5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그룹 5"/>
          <p:cNvGrpSpPr/>
          <p:nvPr/>
        </p:nvGrpSpPr>
        <p:grpSpPr>
          <a:xfrm>
            <a:off x="-1440" y="181080"/>
            <a:ext cx="6967440" cy="8962200"/>
            <a:chOff x="-1440" y="181080"/>
            <a:chExt cx="6967440" cy="8962200"/>
          </a:xfrm>
        </p:grpSpPr>
        <p:pic>
          <p:nvPicPr>
            <p:cNvPr id="42" name="차트 1" descr=""/>
            <p:cNvPicPr/>
            <p:nvPr/>
          </p:nvPicPr>
          <p:blipFill>
            <a:blip r:embed="rId1"/>
            <a:stretch/>
          </p:blipFill>
          <p:spPr>
            <a:xfrm>
              <a:off x="127800" y="463320"/>
              <a:ext cx="3303000" cy="282852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43" name="차트 2" descr=""/>
            <p:cNvPicPr/>
            <p:nvPr/>
          </p:nvPicPr>
          <p:blipFill>
            <a:blip r:embed="rId2"/>
            <a:stretch/>
          </p:blipFill>
          <p:spPr>
            <a:xfrm>
              <a:off x="3425040" y="493560"/>
              <a:ext cx="3540960" cy="279792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44" name="차트 3" descr=""/>
            <p:cNvPicPr/>
            <p:nvPr/>
          </p:nvPicPr>
          <p:blipFill>
            <a:blip r:embed="rId3"/>
            <a:stretch/>
          </p:blipFill>
          <p:spPr>
            <a:xfrm>
              <a:off x="127800" y="3615120"/>
              <a:ext cx="3303000" cy="282852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45" name="차트 4" descr=""/>
            <p:cNvPicPr/>
            <p:nvPr/>
          </p:nvPicPr>
          <p:blipFill>
            <a:blip r:embed="rId4"/>
            <a:stretch/>
          </p:blipFill>
          <p:spPr>
            <a:xfrm>
              <a:off x="3425040" y="3615120"/>
              <a:ext cx="3540960" cy="282852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46" name="TextBox 21"/>
            <p:cNvSpPr/>
            <p:nvPr/>
          </p:nvSpPr>
          <p:spPr>
            <a:xfrm rot="16200000">
              <a:off x="-1067400" y="4676040"/>
              <a:ext cx="237636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No. of trichomoniasis male patients per 100,000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7" name="TextBox 21"/>
            <p:cNvSpPr/>
            <p:nvPr/>
          </p:nvSpPr>
          <p:spPr>
            <a:xfrm rot="16200000">
              <a:off x="-1081440" y="1546560"/>
              <a:ext cx="237636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No. of trichomoniasis male patients per 100,000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8" name="TextBox 21"/>
            <p:cNvSpPr/>
            <p:nvPr/>
          </p:nvSpPr>
          <p:spPr>
            <a:xfrm rot="16200000">
              <a:off x="2151000" y="1457640"/>
              <a:ext cx="255420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No. of trichomoniasis female patients per 100,000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9" name="TextBox 21"/>
            <p:cNvSpPr/>
            <p:nvPr/>
          </p:nvSpPr>
          <p:spPr>
            <a:xfrm rot="16200000">
              <a:off x="2151000" y="4634640"/>
              <a:ext cx="255420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No. of trichomoniasis female patients per 100,000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0" name="TextBox 12"/>
            <p:cNvSpPr/>
            <p:nvPr/>
          </p:nvSpPr>
          <p:spPr>
            <a:xfrm>
              <a:off x="1045800" y="181080"/>
              <a:ext cx="180432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Arial"/>
                  <a:ea typeface="Arial"/>
                </a:rPr>
                <a:t>Jeonbuk/male</a:t>
              </a: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1" name="TextBox 13"/>
            <p:cNvSpPr/>
            <p:nvPr/>
          </p:nvSpPr>
          <p:spPr>
            <a:xfrm>
              <a:off x="4447080" y="185760"/>
              <a:ext cx="180432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Arial"/>
                  <a:ea typeface="Arial"/>
                </a:rPr>
                <a:t>Jeonbuk/female</a:t>
              </a: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2" name="TextBox 14"/>
            <p:cNvSpPr/>
            <p:nvPr/>
          </p:nvSpPr>
          <p:spPr>
            <a:xfrm>
              <a:off x="1157040" y="3435480"/>
              <a:ext cx="124560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Arial"/>
                  <a:ea typeface="Arial"/>
                </a:rPr>
                <a:t>Jeju/male</a:t>
              </a: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3" name="TextBox 15"/>
            <p:cNvSpPr/>
            <p:nvPr/>
          </p:nvSpPr>
          <p:spPr>
            <a:xfrm>
              <a:off x="4626360" y="3435480"/>
              <a:ext cx="138708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Arial"/>
                  <a:ea typeface="Arial"/>
                </a:rPr>
                <a:t>Jeju/female</a:t>
              </a: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4" name="TextBox 27"/>
            <p:cNvSpPr/>
            <p:nvPr/>
          </p:nvSpPr>
          <p:spPr>
            <a:xfrm>
              <a:off x="5677200" y="8775000"/>
              <a:ext cx="117900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Arial"/>
                  <a:ea typeface="Arial"/>
                </a:rPr>
                <a:t>S2 Figure</a:t>
              </a: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5568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6-04-22T05:13:32Z</dcterms:created>
  <dc:creator>Hong</dc:creator>
  <dc:description/>
  <dc:language>en-US</dc:language>
  <cp:lastModifiedBy>Hong</cp:lastModifiedBy>
  <dcterms:modified xsi:type="dcterms:W3CDTF">2016-11-18T05:30:29Z</dcterms:modified>
  <cp:revision>34</cp:revision>
  <dc:subject/>
  <dc:title>PowerPoint 프레젠테이션</dc:title>
</cp:coreProperties>
</file>